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8" d="100"/>
          <a:sy n="88" d="100"/>
        </p:scale>
        <p:origin x="1314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FD07AEB-43B3-410D-982F-61868FBB60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203494-EFB4-41E1-AD8E-83F949477F7E}" type="datetimeFigureOut">
              <a:rPr lang="zh-CN" altLang="en-US"/>
              <a:pPr>
                <a:defRPr/>
              </a:pPr>
              <a:t>2022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FA2CA5A-789E-4E23-8133-BBC9AF50B2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8582A8B-09BC-4EED-98AF-1AF010545C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59C0DA1-F8C0-42AF-86D0-50D07775A4EA}" type="slidenum">
              <a:rPr lang="zh-CN" altLang="en-US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29336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2400487-0818-4901-B60B-2483F784EB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4A906F-FA4A-4AC9-8484-F1ABF55930FB}" type="datetimeFigureOut">
              <a:rPr lang="zh-CN" altLang="en-US"/>
              <a:pPr>
                <a:defRPr/>
              </a:pPr>
              <a:t>2022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280A49C-6E59-4149-AE20-9CF9BD4AEA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65742EF-3126-4715-83FE-EED12CA8A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346D58F-3309-4680-8FC1-7F57801E33B8}" type="slidenum">
              <a:rPr lang="zh-CN" altLang="en-US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01122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8AF0A7B-E5E5-4D56-A001-CCD1042B12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DD2E4E-7B44-4E6A-A22B-1030F80886D8}" type="datetimeFigureOut">
              <a:rPr lang="zh-CN" altLang="en-US"/>
              <a:pPr>
                <a:defRPr/>
              </a:pPr>
              <a:t>2022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4166977-6E2A-45B0-BB1B-283EA2EAE5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0314C2D-0334-480D-9E99-553F8D3EC8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47B029E-36D2-48DA-B98C-0B5BFEF22F58}" type="slidenum">
              <a:rPr lang="zh-CN" altLang="en-US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3402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09F6FAE-1D1F-4B6F-BD05-460608838C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2360D6-96EB-47C6-9EC1-A716F4BC9432}" type="datetimeFigureOut">
              <a:rPr lang="zh-CN" altLang="en-US"/>
              <a:pPr>
                <a:defRPr/>
              </a:pPr>
              <a:t>2022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F9AA574-8A70-4E06-AA71-2E9C408D8F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3D3F4EA-C84E-4DBC-B314-16D6A9E20B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F32A2AB-2737-4489-BBC0-369FEEF0A9BA}" type="slidenum">
              <a:rPr lang="zh-CN" altLang="en-US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64416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D60C103-D502-40B2-BCA9-02346FEFAA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7584A8-0DB9-43C8-9BEF-30295958D6B4}" type="datetimeFigureOut">
              <a:rPr lang="zh-CN" altLang="en-US"/>
              <a:pPr>
                <a:defRPr/>
              </a:pPr>
              <a:t>2022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242339F-E1DA-41CD-9BC0-5A37207241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B2FFE33-7162-4E5B-B121-295620CC05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E830F6C-42C7-4607-9262-DC0EAAAD63D2}" type="slidenum">
              <a:rPr lang="zh-CN" altLang="en-US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1973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3">
            <a:extLst>
              <a:ext uri="{FF2B5EF4-FFF2-40B4-BE49-F238E27FC236}">
                <a16:creationId xmlns:a16="http://schemas.microsoft.com/office/drawing/2014/main" id="{69EE633D-AB47-4240-BE83-E5BA430D6E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A6A490-EC4D-40D1-89C3-D57952C9A1F5}" type="datetimeFigureOut">
              <a:rPr lang="zh-CN" altLang="en-US"/>
              <a:pPr>
                <a:defRPr/>
              </a:pPr>
              <a:t>2022/3/7</a:t>
            </a:fld>
            <a:endParaRPr lang="zh-CN" altLang="en-US"/>
          </a:p>
        </p:txBody>
      </p:sp>
      <p:sp>
        <p:nvSpPr>
          <p:cNvPr id="6" name="页脚占位符 4">
            <a:extLst>
              <a:ext uri="{FF2B5EF4-FFF2-40B4-BE49-F238E27FC236}">
                <a16:creationId xmlns:a16="http://schemas.microsoft.com/office/drawing/2014/main" id="{664620D2-FFDB-4389-B874-E6350B15B8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>
            <a:extLst>
              <a:ext uri="{FF2B5EF4-FFF2-40B4-BE49-F238E27FC236}">
                <a16:creationId xmlns:a16="http://schemas.microsoft.com/office/drawing/2014/main" id="{073875F6-D195-4D5E-979E-5BF5E24D29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A44DF0C-05BE-4C44-802C-E6C8581DD96D}" type="slidenum">
              <a:rPr lang="zh-CN" altLang="en-US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1809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3">
            <a:extLst>
              <a:ext uri="{FF2B5EF4-FFF2-40B4-BE49-F238E27FC236}">
                <a16:creationId xmlns:a16="http://schemas.microsoft.com/office/drawing/2014/main" id="{AF28658F-9FF7-49D9-B853-ECC55FE927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7180CA-55E8-4CF7-AD6C-A6DE57A3B0C6}" type="datetimeFigureOut">
              <a:rPr lang="zh-CN" altLang="en-US"/>
              <a:pPr>
                <a:defRPr/>
              </a:pPr>
              <a:t>2022/3/7</a:t>
            </a:fld>
            <a:endParaRPr lang="zh-CN" altLang="en-US"/>
          </a:p>
        </p:txBody>
      </p:sp>
      <p:sp>
        <p:nvSpPr>
          <p:cNvPr id="8" name="页脚占位符 4">
            <a:extLst>
              <a:ext uri="{FF2B5EF4-FFF2-40B4-BE49-F238E27FC236}">
                <a16:creationId xmlns:a16="http://schemas.microsoft.com/office/drawing/2014/main" id="{D9C2200F-E36B-4B97-AA45-1020802756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灯片编号占位符 5">
            <a:extLst>
              <a:ext uri="{FF2B5EF4-FFF2-40B4-BE49-F238E27FC236}">
                <a16:creationId xmlns:a16="http://schemas.microsoft.com/office/drawing/2014/main" id="{B965DD30-5D10-4BE0-9181-A688430B88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027A302-23AE-4987-9160-88E8DEF697C5}" type="slidenum">
              <a:rPr lang="zh-CN" altLang="en-US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3347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3">
            <a:extLst>
              <a:ext uri="{FF2B5EF4-FFF2-40B4-BE49-F238E27FC236}">
                <a16:creationId xmlns:a16="http://schemas.microsoft.com/office/drawing/2014/main" id="{759796C3-B046-440C-8B01-0F0C1B22A1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42CF70-650F-474A-AC07-7A94BFA8D8BB}" type="datetimeFigureOut">
              <a:rPr lang="zh-CN" altLang="en-US"/>
              <a:pPr>
                <a:defRPr/>
              </a:pPr>
              <a:t>2022/3/7</a:t>
            </a:fld>
            <a:endParaRPr lang="zh-CN" altLang="en-US"/>
          </a:p>
        </p:txBody>
      </p:sp>
      <p:sp>
        <p:nvSpPr>
          <p:cNvPr id="4" name="页脚占位符 4">
            <a:extLst>
              <a:ext uri="{FF2B5EF4-FFF2-40B4-BE49-F238E27FC236}">
                <a16:creationId xmlns:a16="http://schemas.microsoft.com/office/drawing/2014/main" id="{B2B2210E-243B-464B-AA21-20E678B1D7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5">
            <a:extLst>
              <a:ext uri="{FF2B5EF4-FFF2-40B4-BE49-F238E27FC236}">
                <a16:creationId xmlns:a16="http://schemas.microsoft.com/office/drawing/2014/main" id="{430177AD-9533-4A65-AFC9-513A1A534B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871AB66-79AA-4AE8-A736-D9B655E5E221}" type="slidenum">
              <a:rPr lang="zh-CN" altLang="en-US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50148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>
            <a:extLst>
              <a:ext uri="{FF2B5EF4-FFF2-40B4-BE49-F238E27FC236}">
                <a16:creationId xmlns:a16="http://schemas.microsoft.com/office/drawing/2014/main" id="{93E7B8CB-C786-444D-94B9-7188A76B80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D7D41F-E98C-480F-B8A0-323E1E519B16}" type="datetimeFigureOut">
              <a:rPr lang="zh-CN" altLang="en-US"/>
              <a:pPr>
                <a:defRPr/>
              </a:pPr>
              <a:t>2022/3/7</a:t>
            </a:fld>
            <a:endParaRPr lang="zh-CN" altLang="en-US"/>
          </a:p>
        </p:txBody>
      </p:sp>
      <p:sp>
        <p:nvSpPr>
          <p:cNvPr id="3" name="页脚占位符 4">
            <a:extLst>
              <a:ext uri="{FF2B5EF4-FFF2-40B4-BE49-F238E27FC236}">
                <a16:creationId xmlns:a16="http://schemas.microsoft.com/office/drawing/2014/main" id="{C1FFBA79-BDCE-4CF8-A62A-6032DABD9F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灯片编号占位符 5">
            <a:extLst>
              <a:ext uri="{FF2B5EF4-FFF2-40B4-BE49-F238E27FC236}">
                <a16:creationId xmlns:a16="http://schemas.microsoft.com/office/drawing/2014/main" id="{6AAA1EF2-7785-4C62-BF23-E2880D5C20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7D95FC5-B43D-49FA-AF92-77DEEFD9BF1C}" type="slidenum">
              <a:rPr lang="zh-CN" altLang="en-US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94455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3">
            <a:extLst>
              <a:ext uri="{FF2B5EF4-FFF2-40B4-BE49-F238E27FC236}">
                <a16:creationId xmlns:a16="http://schemas.microsoft.com/office/drawing/2014/main" id="{86EB188C-78D3-49FD-9877-E8580C431A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11659D-67F3-42F8-A2C4-DCBE9E396652}" type="datetimeFigureOut">
              <a:rPr lang="zh-CN" altLang="en-US"/>
              <a:pPr>
                <a:defRPr/>
              </a:pPr>
              <a:t>2022/3/7</a:t>
            </a:fld>
            <a:endParaRPr lang="zh-CN" altLang="en-US"/>
          </a:p>
        </p:txBody>
      </p:sp>
      <p:sp>
        <p:nvSpPr>
          <p:cNvPr id="6" name="页脚占位符 4">
            <a:extLst>
              <a:ext uri="{FF2B5EF4-FFF2-40B4-BE49-F238E27FC236}">
                <a16:creationId xmlns:a16="http://schemas.microsoft.com/office/drawing/2014/main" id="{02E83B4E-2ACE-43B1-9E71-311CC0F388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>
            <a:extLst>
              <a:ext uri="{FF2B5EF4-FFF2-40B4-BE49-F238E27FC236}">
                <a16:creationId xmlns:a16="http://schemas.microsoft.com/office/drawing/2014/main" id="{230EC3B3-65FF-4B94-9190-0694FFC224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EC77814-F47A-4234-B300-7459611286EE}" type="slidenum">
              <a:rPr lang="zh-CN" altLang="en-US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5332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3">
            <a:extLst>
              <a:ext uri="{FF2B5EF4-FFF2-40B4-BE49-F238E27FC236}">
                <a16:creationId xmlns:a16="http://schemas.microsoft.com/office/drawing/2014/main" id="{2AC7D151-83E4-409E-8AD3-1EE596DED5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6AFC1F-EDF4-49A9-B72E-AB51B88E5434}" type="datetimeFigureOut">
              <a:rPr lang="zh-CN" altLang="en-US"/>
              <a:pPr>
                <a:defRPr/>
              </a:pPr>
              <a:t>2022/3/7</a:t>
            </a:fld>
            <a:endParaRPr lang="zh-CN" altLang="en-US"/>
          </a:p>
        </p:txBody>
      </p:sp>
      <p:sp>
        <p:nvSpPr>
          <p:cNvPr id="6" name="页脚占位符 4">
            <a:extLst>
              <a:ext uri="{FF2B5EF4-FFF2-40B4-BE49-F238E27FC236}">
                <a16:creationId xmlns:a16="http://schemas.microsoft.com/office/drawing/2014/main" id="{88F811CF-1ECD-403F-90B8-2D3E23D39E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>
            <a:extLst>
              <a:ext uri="{FF2B5EF4-FFF2-40B4-BE49-F238E27FC236}">
                <a16:creationId xmlns:a16="http://schemas.microsoft.com/office/drawing/2014/main" id="{EB2BBD31-F36F-4B2B-ACB2-32D75D263A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DA3AB81-BE19-4908-8846-F1095DE6B7EF}" type="slidenum">
              <a:rPr lang="zh-CN" altLang="en-US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68507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标题占位符 1">
            <a:extLst>
              <a:ext uri="{FF2B5EF4-FFF2-40B4-BE49-F238E27FC236}">
                <a16:creationId xmlns:a16="http://schemas.microsoft.com/office/drawing/2014/main" id="{7E25B6B0-DB5B-4802-82EC-8B54E98BBBB8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5123" name="文本占位符 2">
            <a:extLst>
              <a:ext uri="{FF2B5EF4-FFF2-40B4-BE49-F238E27FC236}">
                <a16:creationId xmlns:a16="http://schemas.microsoft.com/office/drawing/2014/main" id="{F32E6789-F18D-4455-9EDC-5162AB3E48E9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DDE2F5D-99BD-4420-ABB8-C239721D09C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A06E3127-DBBD-4457-AA52-A04C27CE919C}" type="datetimeFigureOut">
              <a:rPr lang="zh-CN" altLang="en-US"/>
              <a:pPr>
                <a:defRPr/>
              </a:pPr>
              <a:t>2022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1CAFACD-7CC1-4BBD-ACCF-6E8023C19BC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1A4B2AF-B817-4809-AB6E-3215074125D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fld id="{664F5FAC-0C44-435E-8E00-AFA26FA13D76}" type="slidenum">
              <a:rPr lang="zh-CN" altLang="en-US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8" name="TextBox 3">
            <a:extLst>
              <a:ext uri="{FF2B5EF4-FFF2-40B4-BE49-F238E27FC236}">
                <a16:creationId xmlns:a16="http://schemas.microsoft.com/office/drawing/2014/main" id="{F36D3FB8-7388-4D9A-B9BA-42C0E5C506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9613" y="260350"/>
            <a:ext cx="5195887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2400">
                <a:latin typeface="Arial" panose="020B0604020202020204" pitchFamily="34" charset="0"/>
                <a:cs typeface="Arial" panose="020B0604020202020204" pitchFamily="34" charset="0"/>
              </a:rPr>
              <a:t>Supporting data for "data not shown"</a:t>
            </a:r>
            <a:endParaRPr lang="zh-CN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9" name="TextBox 4">
            <a:extLst>
              <a:ext uri="{FF2B5EF4-FFF2-40B4-BE49-F238E27FC236}">
                <a16:creationId xmlns:a16="http://schemas.microsoft.com/office/drawing/2014/main" id="{303C6934-AFB7-4110-8745-7FD877F267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03350" y="4005263"/>
            <a:ext cx="6913563" cy="14773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just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Figure 1.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Hemagglutination-inhibition (HI) titers of three viruses-vaccinated sera in 1-day-old chicks (A) and 2-week-old chickens (B) were analyzed. The serological reaction of each sera to three viruses B1,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Sot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Ban/AF was performed by HI assay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0" name="Rectangle 2">
            <a:extLst>
              <a:ext uri="{FF2B5EF4-FFF2-40B4-BE49-F238E27FC236}">
                <a16:creationId xmlns:a16="http://schemas.microsoft.com/office/drawing/2014/main" id="{E71D2A84-A537-4EB3-BD16-5BD5408A03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endParaRPr lang="zh-CN" altLang="en-US"/>
          </a:p>
        </p:txBody>
      </p:sp>
      <p:graphicFrame>
        <p:nvGraphicFramePr>
          <p:cNvPr id="1026" name="Object 1">
            <a:extLst>
              <a:ext uri="{FF2B5EF4-FFF2-40B4-BE49-F238E27FC236}">
                <a16:creationId xmlns:a16="http://schemas.microsoft.com/office/drawing/2014/main" id="{8A25036E-3F8E-43C6-9889-83BEC7B2897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68313" y="1052513"/>
          <a:ext cx="4087812" cy="2736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6" name="Prism Project" r:id="rId3" imgW="4788000" imgH="3204000" progId="Prism5.Document">
                  <p:embed/>
                </p:oleObj>
              </mc:Choice>
              <mc:Fallback>
                <p:oleObj name="Prism Project" r:id="rId3" imgW="4788000" imgH="3204000" progId="Prism5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8313" y="1052513"/>
                        <a:ext cx="4087812" cy="273685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31" name="Rectangle 4">
            <a:extLst>
              <a:ext uri="{FF2B5EF4-FFF2-40B4-BE49-F238E27FC236}">
                <a16:creationId xmlns:a16="http://schemas.microsoft.com/office/drawing/2014/main" id="{8EA6CA60-F53C-4433-B81A-13D074210F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endParaRPr lang="zh-CN" altLang="en-US"/>
          </a:p>
        </p:txBody>
      </p:sp>
      <p:graphicFrame>
        <p:nvGraphicFramePr>
          <p:cNvPr id="1027" name="Object 3">
            <a:extLst>
              <a:ext uri="{FF2B5EF4-FFF2-40B4-BE49-F238E27FC236}">
                <a16:creationId xmlns:a16="http://schemas.microsoft.com/office/drawing/2014/main" id="{79B867CA-3B3A-42E3-8D3B-703EFF976E4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643438" y="1028700"/>
          <a:ext cx="4133850" cy="27606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7" name="Prism Project" r:id="rId5" imgW="4788000" imgH="3204000" progId="Prism5.Document">
                  <p:embed/>
                </p:oleObj>
              </mc:Choice>
              <mc:Fallback>
                <p:oleObj name="Prism Project" r:id="rId5" imgW="4788000" imgH="3204000" progId="Prism5.Document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43438" y="1028700"/>
                        <a:ext cx="4133850" cy="2760663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32" name="TextBox 13">
            <a:extLst>
              <a:ext uri="{FF2B5EF4-FFF2-40B4-BE49-F238E27FC236}">
                <a16:creationId xmlns:a16="http://schemas.microsoft.com/office/drawing/2014/main" id="{8F92FFF6-6298-41F6-93FC-512B6F4FC0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3850" y="908050"/>
            <a:ext cx="388938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zh-CN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3" name="TextBox 15">
            <a:extLst>
              <a:ext uri="{FF2B5EF4-FFF2-40B4-BE49-F238E27FC236}">
                <a16:creationId xmlns:a16="http://schemas.microsoft.com/office/drawing/2014/main" id="{7523F24F-372E-4158-A5E5-FDFB0ECE64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27538" y="930275"/>
            <a:ext cx="390525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zh-CN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21089F1-5FB6-41E5-A629-72954344D62F}"/>
              </a:ext>
            </a:extLst>
          </p:cNvPr>
          <p:cNvSpPr txBox="1"/>
          <p:nvPr/>
        </p:nvSpPr>
        <p:spPr>
          <a:xfrm>
            <a:off x="520845" y="5978683"/>
            <a:ext cx="84241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70C0"/>
                </a:solidFill>
              </a:rPr>
              <a:t>Provided to support the statement, “The sera from Ban/AF immunized 1-day old chicks had the same HI titer to Ban/AF and B1 viruses, and somewhat lower to </a:t>
            </a:r>
            <a:r>
              <a:rPr lang="en-US" sz="1200" dirty="0" err="1">
                <a:solidFill>
                  <a:srgbClr val="0070C0"/>
                </a:solidFill>
              </a:rPr>
              <a:t>LaSota</a:t>
            </a:r>
            <a:r>
              <a:rPr lang="en-US" sz="1200" dirty="0">
                <a:solidFill>
                  <a:srgbClr val="0070C0"/>
                </a:solidFill>
              </a:rPr>
              <a:t> (data not shown). Similar results for HI serum antibodies were found with 2-week-old immunized chickens.” 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2" name="TextBox 3">
            <a:extLst>
              <a:ext uri="{FF2B5EF4-FFF2-40B4-BE49-F238E27FC236}">
                <a16:creationId xmlns:a16="http://schemas.microsoft.com/office/drawing/2014/main" id="{25353156-4085-4BBB-A176-2FD8E87DBA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0825" y="3140944"/>
            <a:ext cx="8424863" cy="25545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just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Figure 2.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neutralizing antibody titers of vaccinated 1-day-old chicks (A) and 2-week-old (B) were analyzed by virus-neutralization assay. This assay of each sera to three viruses B1,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Sota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Ban/AF was respectively carried out. For virus-neutralization assay, 2-fold serial dilutions of 100 µl of heat-inactivated sera were mixed with 100 TCID</a:t>
            </a:r>
            <a:r>
              <a:rPr lang="en-US" altLang="zh-CN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of the viruses and incubated at 37</a:t>
            </a:r>
            <a:r>
              <a:rPr lang="en-US" altLang="zh-CN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for 1 h. After incubation, a 50 µl volume of the virus-serum mixture from each serum dilution was added to approximately 200 µl of medium in quintuplicate wells of DF-1 cells in 96-well plates. The plates were then incubated at 37</a:t>
            </a:r>
            <a:r>
              <a:rPr lang="en-US" altLang="zh-CN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for 48 h. The viruses in the infected cells were detected by immunofluorescence assay using anti-NDV polyclonal antibody. The titer was defined as the mean reciprocal log</a:t>
            </a:r>
            <a:r>
              <a:rPr lang="en-US" altLang="zh-CN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of the highest serum dilution resulting in complete neutralization of infection in 50% of the wells.</a:t>
            </a:r>
            <a:endParaRPr lang="zh-CN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3" name="Rectangle 2">
            <a:extLst>
              <a:ext uri="{FF2B5EF4-FFF2-40B4-BE49-F238E27FC236}">
                <a16:creationId xmlns:a16="http://schemas.microsoft.com/office/drawing/2014/main" id="{53650BFD-BC34-4E6D-94C9-B48B16CC78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endParaRPr lang="zh-CN" altLang="en-US"/>
          </a:p>
        </p:txBody>
      </p:sp>
      <p:graphicFrame>
        <p:nvGraphicFramePr>
          <p:cNvPr id="2050" name="Object 1">
            <a:extLst>
              <a:ext uri="{FF2B5EF4-FFF2-40B4-BE49-F238E27FC236}">
                <a16:creationId xmlns:a16="http://schemas.microsoft.com/office/drawing/2014/main" id="{A2B37C97-C8BF-424B-9304-1C617D94E9C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725541"/>
              </p:ext>
            </p:extLst>
          </p:nvPr>
        </p:nvGraphicFramePr>
        <p:xfrm>
          <a:off x="539750" y="475531"/>
          <a:ext cx="3967163" cy="2665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9" name="Prism Project" r:id="rId3" imgW="4788000" imgH="3204000" progId="Prism5.Document">
                  <p:embed/>
                </p:oleObj>
              </mc:Choice>
              <mc:Fallback>
                <p:oleObj name="Prism Project" r:id="rId3" imgW="4788000" imgH="3204000" progId="Prism5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39750" y="475531"/>
                        <a:ext cx="3967163" cy="2665413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54" name="Rectangle 4">
            <a:extLst>
              <a:ext uri="{FF2B5EF4-FFF2-40B4-BE49-F238E27FC236}">
                <a16:creationId xmlns:a16="http://schemas.microsoft.com/office/drawing/2014/main" id="{3A9885BB-5356-4CB5-92B5-A1645C7573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endParaRPr lang="zh-CN" altLang="en-US"/>
          </a:p>
        </p:txBody>
      </p:sp>
      <p:graphicFrame>
        <p:nvGraphicFramePr>
          <p:cNvPr id="2051" name="Object 3">
            <a:extLst>
              <a:ext uri="{FF2B5EF4-FFF2-40B4-BE49-F238E27FC236}">
                <a16:creationId xmlns:a16="http://schemas.microsoft.com/office/drawing/2014/main" id="{57E1A316-040A-4494-951A-9D7E132CF0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7433429"/>
              </p:ext>
            </p:extLst>
          </p:nvPr>
        </p:nvGraphicFramePr>
        <p:xfrm>
          <a:off x="4630738" y="475531"/>
          <a:ext cx="3973512" cy="2665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0" name="Prism Project" r:id="rId5" imgW="4788000" imgH="3204000" progId="Prism5.Document">
                  <p:embed/>
                </p:oleObj>
              </mc:Choice>
              <mc:Fallback>
                <p:oleObj name="Prism Project" r:id="rId5" imgW="4788000" imgH="3204000" progId="Prism5.Document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30738" y="475531"/>
                        <a:ext cx="3973512" cy="2665413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55" name="TextBox 10">
            <a:extLst>
              <a:ext uri="{FF2B5EF4-FFF2-40B4-BE49-F238E27FC236}">
                <a16:creationId xmlns:a16="http://schemas.microsoft.com/office/drawing/2014/main" id="{3219E59A-3855-4411-8C7D-B1A7FD7631E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3850" y="332656"/>
            <a:ext cx="3889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zh-CN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6" name="TextBox 11">
            <a:extLst>
              <a:ext uri="{FF2B5EF4-FFF2-40B4-BE49-F238E27FC236}">
                <a16:creationId xmlns:a16="http://schemas.microsoft.com/office/drawing/2014/main" id="{4F6BD6C9-F59C-4D25-9CBC-9B9E49DBBF2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27538" y="353294"/>
            <a:ext cx="390525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zh-CN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345B877-B732-47F4-92E5-ED6BFDCCA035}"/>
              </a:ext>
            </a:extLst>
          </p:cNvPr>
          <p:cNvSpPr txBox="1"/>
          <p:nvPr/>
        </p:nvSpPr>
        <p:spPr>
          <a:xfrm>
            <a:off x="355945" y="5774055"/>
            <a:ext cx="856818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70C0"/>
                </a:solidFill>
              </a:rPr>
              <a:t>Provided to support the following statements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200" dirty="0">
                <a:solidFill>
                  <a:srgbClr val="0070C0"/>
                </a:solidFill>
              </a:rPr>
              <a:t>“The serum neutralization analysis showed that each serum neutralized the heterologous viruses, but the neutralization titers were always 2 to 4-fold higher to homologous strain than to heterologous strains (data not shown).”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200" dirty="0">
                <a:solidFill>
                  <a:srgbClr val="0070C0"/>
                </a:solidFill>
              </a:rPr>
              <a:t>“Similarly, higher neutralization titers were also observed in 2-week-old chicken sera immunized with Ban/AF virus against the seven other Indonesian strains (data not shown).”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6" name="TextBox 3">
            <a:extLst>
              <a:ext uri="{FF2B5EF4-FFF2-40B4-BE49-F238E27FC236}">
                <a16:creationId xmlns:a16="http://schemas.microsoft.com/office/drawing/2014/main" id="{A62A5670-820A-40FE-9884-CF934C6615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03350" y="4005263"/>
            <a:ext cx="6769100" cy="12003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just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Figure 3.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wo week-old chickens were immunized with Ban/AF or PBS as a control. After three weeks, the chickens were challenged through intranasal (IN) route with Ban/010 (A) and GB Texas (B). The survivals of all chickens were monitored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77" name="Rectangle 2">
            <a:extLst>
              <a:ext uri="{FF2B5EF4-FFF2-40B4-BE49-F238E27FC236}">
                <a16:creationId xmlns:a16="http://schemas.microsoft.com/office/drawing/2014/main" id="{160EA2DE-B525-46EF-B203-8F0877BE32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endParaRPr lang="zh-CN" altLang="en-US"/>
          </a:p>
        </p:txBody>
      </p:sp>
      <p:graphicFrame>
        <p:nvGraphicFramePr>
          <p:cNvPr id="3074" name="Object 1">
            <a:extLst>
              <a:ext uri="{FF2B5EF4-FFF2-40B4-BE49-F238E27FC236}">
                <a16:creationId xmlns:a16="http://schemas.microsoft.com/office/drawing/2014/main" id="{97EF1B22-CB70-4E21-B80B-C4571B34BF0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93688" y="1052513"/>
          <a:ext cx="4332287" cy="2592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3" name="Prism Project" r:id="rId3" imgW="4824000" imgH="2880000" progId="Prism5.Document">
                  <p:embed/>
                </p:oleObj>
              </mc:Choice>
              <mc:Fallback>
                <p:oleObj name="Prism Project" r:id="rId3" imgW="4824000" imgH="2880000" progId="Prism5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3688" y="1052513"/>
                        <a:ext cx="4332287" cy="2592387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78" name="Rectangle 4">
            <a:extLst>
              <a:ext uri="{FF2B5EF4-FFF2-40B4-BE49-F238E27FC236}">
                <a16:creationId xmlns:a16="http://schemas.microsoft.com/office/drawing/2014/main" id="{D7B52338-C379-4C34-8337-C2FDE48B07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endParaRPr lang="zh-CN" altLang="en-US"/>
          </a:p>
        </p:txBody>
      </p:sp>
      <p:graphicFrame>
        <p:nvGraphicFramePr>
          <p:cNvPr id="3075" name="Object 3">
            <a:extLst>
              <a:ext uri="{FF2B5EF4-FFF2-40B4-BE49-F238E27FC236}">
                <a16:creationId xmlns:a16="http://schemas.microsoft.com/office/drawing/2014/main" id="{D08116A6-CE9B-4B20-8014-03689680F7A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613275" y="1052513"/>
          <a:ext cx="4351338" cy="2592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4" name="Prism Project" r:id="rId5" imgW="4824000" imgH="2880000" progId="Prism5.Document">
                  <p:embed/>
                </p:oleObj>
              </mc:Choice>
              <mc:Fallback>
                <p:oleObj name="Prism Project" r:id="rId5" imgW="4824000" imgH="2880000" progId="Prism5.Document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13275" y="1052513"/>
                        <a:ext cx="4351338" cy="2592387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79" name="TextBox 10">
            <a:extLst>
              <a:ext uri="{FF2B5EF4-FFF2-40B4-BE49-F238E27FC236}">
                <a16:creationId xmlns:a16="http://schemas.microsoft.com/office/drawing/2014/main" id="{D84FFB13-DF69-4F5D-A655-5B4DFA1F6E5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9225" y="908050"/>
            <a:ext cx="390525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zh-CN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80" name="TextBox 11">
            <a:extLst>
              <a:ext uri="{FF2B5EF4-FFF2-40B4-BE49-F238E27FC236}">
                <a16:creationId xmlns:a16="http://schemas.microsoft.com/office/drawing/2014/main" id="{5870B697-921C-4B8D-9918-17D03F966A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97375" y="930275"/>
            <a:ext cx="390525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zh-CN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E4A3989-90BA-487B-8B63-5DD187667EDF}"/>
              </a:ext>
            </a:extLst>
          </p:cNvPr>
          <p:cNvSpPr txBox="1"/>
          <p:nvPr/>
        </p:nvSpPr>
        <p:spPr>
          <a:xfrm>
            <a:off x="791580" y="5927725"/>
            <a:ext cx="75608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70C0"/>
                </a:solidFill>
              </a:rPr>
              <a:t>Provided to support the statement, “Similarly, 2-week-old chickens vaccinated with Ban/AF or </a:t>
            </a:r>
            <a:r>
              <a:rPr lang="en-US" sz="1200" dirty="0" err="1">
                <a:solidFill>
                  <a:srgbClr val="0070C0"/>
                </a:solidFill>
              </a:rPr>
              <a:t>LaSota</a:t>
            </a:r>
            <a:r>
              <a:rPr lang="en-US" sz="1200" dirty="0">
                <a:solidFill>
                  <a:srgbClr val="0070C0"/>
                </a:solidFill>
              </a:rPr>
              <a:t> were fully protected from clinical disease and mortality from virulent Ban/010 and GB Texas (data not shown).”</a:t>
            </a:r>
          </a:p>
          <a:p>
            <a:endParaRPr lang="en-US" sz="1200" dirty="0">
              <a:solidFill>
                <a:srgbClr val="0070C0"/>
              </a:solidFill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A968D2C7-6DA4-4EBA-BC77-57E8A9999EF6}"/>
              </a:ext>
            </a:extLst>
          </p:cNvPr>
          <p:cNvSpPr/>
          <p:nvPr/>
        </p:nvSpPr>
        <p:spPr>
          <a:xfrm>
            <a:off x="3419872" y="1916832"/>
            <a:ext cx="864096" cy="14401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BEBE43BC-E1DA-49A1-A01A-141022A0EA1B}"/>
              </a:ext>
            </a:extLst>
          </p:cNvPr>
          <p:cNvSpPr/>
          <p:nvPr/>
        </p:nvSpPr>
        <p:spPr>
          <a:xfrm>
            <a:off x="7752159" y="1940349"/>
            <a:ext cx="864096" cy="14401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9" name="TextBox 3">
            <a:extLst>
              <a:ext uri="{FF2B5EF4-FFF2-40B4-BE49-F238E27FC236}">
                <a16:creationId xmlns:a16="http://schemas.microsoft.com/office/drawing/2014/main" id="{B7151007-46C5-480C-A969-B5F257C575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58888" y="3789363"/>
            <a:ext cx="6481762" cy="9233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just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Figure 4.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antibody titers of pre-challenged and post-challenged with viruses Ban/010 and GB Texas in B1 and Ban/AF vaccinated 1-day-old chickens were analyzed by HI assay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00" name="Rectangle 2">
            <a:extLst>
              <a:ext uri="{FF2B5EF4-FFF2-40B4-BE49-F238E27FC236}">
                <a16:creationId xmlns:a16="http://schemas.microsoft.com/office/drawing/2014/main" id="{225B03ED-361C-4125-83BE-8F8901504A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endParaRPr lang="zh-CN" altLang="en-US"/>
          </a:p>
        </p:txBody>
      </p:sp>
      <p:graphicFrame>
        <p:nvGraphicFramePr>
          <p:cNvPr id="4098" name="Object 1">
            <a:extLst>
              <a:ext uri="{FF2B5EF4-FFF2-40B4-BE49-F238E27FC236}">
                <a16:creationId xmlns:a16="http://schemas.microsoft.com/office/drawing/2014/main" id="{510B6DC4-067D-4EFF-AC13-727F49DB2C2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411288" y="620713"/>
          <a:ext cx="6329362" cy="2952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7" name="Prism Project" r:id="rId3" imgW="5652000" imgH="2628000" progId="Prism5.Document">
                  <p:embed/>
                </p:oleObj>
              </mc:Choice>
              <mc:Fallback>
                <p:oleObj name="Prism Project" r:id="rId3" imgW="5652000" imgH="2628000" progId="Prism5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11288" y="620713"/>
                        <a:ext cx="6329362" cy="295275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4BDCB1B0-7FC4-4BCC-BB93-A3BC87D93704}"/>
              </a:ext>
            </a:extLst>
          </p:cNvPr>
          <p:cNvSpPr txBox="1"/>
          <p:nvPr/>
        </p:nvSpPr>
        <p:spPr>
          <a:xfrm>
            <a:off x="467545" y="5805264"/>
            <a:ext cx="835292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70C0"/>
                </a:solidFill>
              </a:rPr>
              <a:t>Provided to support the statement, “These results, together with the observed greater breakthrough shedding of Ban/010 challenge virus as noted above, indicated that B1-induced immunity was comparatively less effective in preventing replication of genotype-mismatched challenge Ban/010 virus. The resulting challenge virus breakthrough led to the greater </a:t>
            </a:r>
            <a:r>
              <a:rPr lang="en-US" sz="1200" dirty="0" err="1">
                <a:solidFill>
                  <a:srgbClr val="0070C0"/>
                </a:solidFill>
              </a:rPr>
              <a:t>postchallenge</a:t>
            </a:r>
            <a:r>
              <a:rPr lang="en-US" sz="1200" dirty="0">
                <a:solidFill>
                  <a:srgbClr val="0070C0"/>
                </a:solidFill>
              </a:rPr>
              <a:t> antibody response (data not shown).”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</TotalTime>
  <Words>549</Words>
  <Application>Microsoft Office PowerPoint</Application>
  <PresentationFormat>On-screen Show (4:3)</PresentationFormat>
  <Paragraphs>17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Times New Roman</vt:lpstr>
      <vt:lpstr>Office 主题</vt:lpstr>
      <vt:lpstr>Prism Project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萧飒</dc:creator>
  <cp:lastModifiedBy>Amaya Reik</cp:lastModifiedBy>
  <cp:revision>26</cp:revision>
  <dcterms:created xsi:type="dcterms:W3CDTF">2020-11-20T01:31:28Z</dcterms:created>
  <dcterms:modified xsi:type="dcterms:W3CDTF">2022-03-07T11:43:48Z</dcterms:modified>
</cp:coreProperties>
</file>